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57" r:id="rId4"/>
    <p:sldId id="263" r:id="rId5"/>
    <p:sldId id="264" r:id="rId6"/>
    <p:sldId id="268" r:id="rId7"/>
    <p:sldId id="265" r:id="rId8"/>
    <p:sldId id="266" r:id="rId9"/>
    <p:sldId id="267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8BBB50-4D48-4DF1-B855-E63F7658B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A6D211D-6AC5-4629-8048-A21E9D7F3F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FC72DD-6796-475E-B99B-835487FA7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6E34D9-1D0B-4B9D-A403-32612E853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5E3ABE-D174-413E-AE53-542344032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6690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4D0A70-977A-4559-817D-2AE44E7C0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7B22A8-9070-466C-88F4-72709E761B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CE395D-E27A-47A8-88A1-6D62AFBFF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26180C-7E71-4B0D-94D9-1D4E4A613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BCAF5E-2F4C-49E9-81A5-B425CD0A9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7643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77F8CCD-8824-457B-B15E-09C8298FA0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321A541-8075-476E-9F4D-490D50CB71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712D26-59CE-4A16-A366-314D4E667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0AFB02-456F-45CA-BEBB-A2E2CFA60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C2A2D2-A3FA-44E9-A8C6-7ADC49CEA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4322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8CEEB2-AE6B-4FD1-AB68-83453D91D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6DFFDA-EA1E-4074-9293-D885D17044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3A9D13-1914-46AF-AF02-41D5328AF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ABA62B-FEA8-4548-B117-6FBFC5A85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9B0796-9994-4CB7-B141-630C8C1FC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1228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DC3A1E-BAFC-4152-93E3-74AE1C387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89A85CA-9967-489C-8145-F727A9A05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1A1CD-BA89-4F4F-BE52-6555AC06B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4E593B-72E1-499C-8FE4-8E24FF6D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01DE7C-2916-4038-8C7B-0663628D4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33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0D0387-13AE-4D37-BFB4-6F83471BA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C0E045-AC48-4FE9-A496-48E4FA511D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12925D-3D3D-4D15-8410-22202426A1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4E6659-80CE-4030-86C4-BCAFC62C2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DA5D4F6-17B2-46B9-A07B-74D56B752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BA0CE6-E1BF-4C78-B116-C1EB3E3FA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311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A7C3E0-675A-416F-977E-3B93190DC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D4280C7-623F-43B9-8498-A00E3E626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1AB6BE2-2A45-486C-B67D-C79A118DFE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FA9E478-9B4F-4F91-A126-1D0DE527D9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463670C-2867-44C6-A3FB-86D4B711BE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661D833-56CD-468D-8AD4-A9ED3C418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1E3D56-C414-43B3-ABCE-7F52D3E88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C9B4E73-7B87-4DB8-A688-1A66CE639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211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776069-893E-495E-8497-E819C22E24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25E9587-32AE-47D4-B928-4619142EE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6189C74-07DF-4B33-B052-89F38D968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B83427F-3096-42AE-A8BB-63C22ED9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4824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D05712D-2B4E-4E9C-977F-89F83FED2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7682F5B-6D77-49BD-9847-B31D74DD8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8D720CC-5D50-4E8B-AF88-CA6D1BE07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365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22F59C-CE5C-49D1-9ECA-31B4527D7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101523A-62B3-496C-8D65-D41D87FB90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4AB250C-46CB-433F-993B-F68F218933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BE650F-4AC0-4F5E-9995-135C6534C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837A29-ED16-4482-9BE0-E6568282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18E7A2-131E-4862-93CC-091DA5273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7375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33DF24-D4F7-4B81-919B-9E6B1AE50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CE9555E-BBEB-4852-9700-C5D9607214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94AC76-3D26-4AB6-BE3D-B4C9089E28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4E5997-6C40-4271-B164-3FC23B239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4FF06FE-D2B7-40F6-BF1F-E8168C583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8A6EEF-D7AD-4E81-9FE6-9B1329D41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7039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43F3F93-7311-4ED9-A6C9-7947D0422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564DEA-5C44-460E-8AE0-DB443E4DF8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8F9C01-A868-42B1-93F7-010EE5731A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F29FB-C7B0-4551-B02D-2A3CAAC4FCCC}" type="datetimeFigureOut">
              <a:rPr lang="zh-CN" altLang="en-US" smtClean="0"/>
              <a:t>2022/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87D532-1866-481E-955A-6293557A85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D1FB51-A535-40B6-A349-4EEF1A2DD8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584DC-8472-4C16-B5A9-0E25A43CC8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696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61BCF9-E2A0-4816-808D-482D06EB79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10877" y="773571"/>
            <a:ext cx="9929567" cy="2387600"/>
          </a:xfrm>
        </p:spPr>
        <p:txBody>
          <a:bodyPr>
            <a:normAutofit/>
          </a:bodyPr>
          <a:lstStyle/>
          <a:p>
            <a:r>
              <a:rPr lang="en-US" altLang="zh-CN" sz="5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C results with different threshold</a:t>
            </a:r>
            <a:endParaRPr lang="zh-CN" altLang="en-US" sz="19900" dirty="0"/>
          </a:p>
        </p:txBody>
      </p:sp>
    </p:spTree>
    <p:extLst>
      <p:ext uri="{BB962C8B-B14F-4D97-AF65-F5344CB8AC3E}">
        <p14:creationId xmlns:p14="http://schemas.microsoft.com/office/powerpoint/2010/main" val="2254868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FBD750-4B2C-4272-AFD0-72AE5EBFE3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13614" y="1391991"/>
            <a:ext cx="10515600" cy="4351338"/>
          </a:xfrm>
        </p:spPr>
        <p:txBody>
          <a:bodyPr/>
          <a:lstStyle/>
          <a:p>
            <a:pPr>
              <a:lnSpc>
                <a:spcPct val="20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n the DC threshold is increased or decreased, the comparison results of MSA_D and MSA_ND are relatively stable. </a:t>
            </a:r>
          </a:p>
          <a:p>
            <a:pPr>
              <a:lnSpc>
                <a:spcPct val="20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he threshold value was set as P &lt; 0.001(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lphaSim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multiple comparisons corrected). MSA-D: multiple system atrophy with depression symptoms; MSA-ND: multiple system atrophy without depression symptoms; HC: healthy controls.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88089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D vs MSA-N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4E04C58D-C3DE-42B5-9B93-AC2996348B6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359" y="1401273"/>
            <a:ext cx="5986909" cy="4785117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2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23928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D vs H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2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41441BE-D441-48B2-99E2-AE835A29CB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3711" y="1326461"/>
            <a:ext cx="6511784" cy="5204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9373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ND vs H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2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内容占位符 7">
            <a:extLst>
              <a:ext uri="{FF2B5EF4-FFF2-40B4-BE49-F238E27FC236}">
                <a16:creationId xmlns:a16="http://schemas.microsoft.com/office/drawing/2014/main" id="{E71C4E89-E28F-46B5-B36B-D514CA72118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5651" y="1376313"/>
            <a:ext cx="6100697" cy="4876064"/>
          </a:xfrm>
        </p:spPr>
      </p:pic>
    </p:spTree>
    <p:extLst>
      <p:ext uri="{BB962C8B-B14F-4D97-AF65-F5344CB8AC3E}">
        <p14:creationId xmlns:p14="http://schemas.microsoft.com/office/powerpoint/2010/main" val="1653343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007663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D vs MSA-N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35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内容占位符 7">
            <a:extLst>
              <a:ext uri="{FF2B5EF4-FFF2-40B4-BE49-F238E27FC236}">
                <a16:creationId xmlns:a16="http://schemas.microsoft.com/office/drawing/2014/main" id="{565EDF34-3876-4374-A435-78B1F36A508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5539" y="1430946"/>
            <a:ext cx="5920922" cy="4995660"/>
          </a:xfrm>
        </p:spPr>
      </p:pic>
    </p:spTree>
    <p:extLst>
      <p:ext uri="{BB962C8B-B14F-4D97-AF65-F5344CB8AC3E}">
        <p14:creationId xmlns:p14="http://schemas.microsoft.com/office/powerpoint/2010/main" val="30246807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D vs H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35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4C730B5-FEED-4B7A-ABB8-33B7E6CAF0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4284" y="1371668"/>
            <a:ext cx="6398662" cy="5114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50886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571F8-74D1-47C2-9A46-EE84E6D51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4250" y="233149"/>
            <a:ext cx="10515600" cy="1325563"/>
          </a:xfrm>
        </p:spPr>
        <p:txBody>
          <a:bodyPr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-ND vs H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96CC3D-5853-4094-A8C1-24C4B19F693C}"/>
              </a:ext>
            </a:extLst>
          </p:cNvPr>
          <p:cNvSpPr txBox="1"/>
          <p:nvPr/>
        </p:nvSpPr>
        <p:spPr>
          <a:xfrm>
            <a:off x="1413577" y="3344001"/>
            <a:ext cx="15087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=0.35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AF6E37A-ED3D-4445-9681-A4C1B79052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2309" y="1405152"/>
            <a:ext cx="6530637" cy="5219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7400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04</Words>
  <Application>Microsoft Office PowerPoint</Application>
  <PresentationFormat>宽屏</PresentationFormat>
  <Paragraphs>15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DC results with different threshold</vt:lpstr>
      <vt:lpstr>PowerPoint 演示文稿</vt:lpstr>
      <vt:lpstr>MSA-D vs MSA-ND</vt:lpstr>
      <vt:lpstr>MSA-D vs HC</vt:lpstr>
      <vt:lpstr>MSA-ND vs HC</vt:lpstr>
      <vt:lpstr>PowerPoint 演示文稿</vt:lpstr>
      <vt:lpstr>MSA-D vs MSA-ND</vt:lpstr>
      <vt:lpstr>MSA-D vs HC</vt:lpstr>
      <vt:lpstr>MSA-ND vs HC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C results with different threshold</dc:title>
  <dc:creator>杨 华光</dc:creator>
  <cp:lastModifiedBy>杨 华光</cp:lastModifiedBy>
  <cp:revision>1</cp:revision>
  <dcterms:created xsi:type="dcterms:W3CDTF">2022-01-07T12:47:16Z</dcterms:created>
  <dcterms:modified xsi:type="dcterms:W3CDTF">2022-01-07T13:17:44Z</dcterms:modified>
</cp:coreProperties>
</file>